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howSpecialPlsOnTitleSld="0" saveSubsetFonts="1" autoCompressPictures="0">
  <p:sldMasterIdLst>
    <p:sldMasterId id="2147483648" r:id="rId1"/>
  </p:sldMasterIdLst>
  <p:notesMasterIdLst>
    <p:notesMasterId r:id="rId3"/>
  </p:notesMasterIdLst>
  <p:sldIdLst>
    <p:sldId id="307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2DCDB"/>
    <a:srgbClr val="0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5423" autoAdjust="0"/>
    <p:restoredTop sz="83673"/>
  </p:normalViewPr>
  <p:slideViewPr>
    <p:cSldViewPr snapToGrid="0" snapToObjects="1">
      <p:cViewPr varScale="1">
        <p:scale>
          <a:sx n="76" d="100"/>
          <a:sy n="76" d="100"/>
        </p:scale>
        <p:origin x="4320" y="20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45C2E0B-27D3-3A4E-9A31-D8A164E3660A}" type="datetimeFigureOut">
              <a:rPr lang="en-US" smtClean="0"/>
              <a:t>6/15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altLang="ko-KR"/>
              <a:t>Click to 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C41AD2B-FE91-6240-AA14-71E5468EBF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636296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7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4287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75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62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50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37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725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0013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300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DE230F-D2B7-B945-A97E-52AFB19C8F45}" type="datetime1">
              <a:rPr lang="en-US" smtClean="0"/>
              <a:t>6/15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88919-8FC4-BE4C-BB49-EFAB79B743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01863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917D6-BDE4-2A4F-AD40-6DC696D1F4C6}" type="datetime1">
              <a:rPr lang="en-US" smtClean="0"/>
              <a:t>6/15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88919-8FC4-BE4C-BB49-EFAB79B743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3298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94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94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9DA71D-5127-EE49-94F2-7A701A6AB1BD}" type="datetime1">
              <a:rPr lang="en-US" smtClean="0"/>
              <a:t>6/15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88919-8FC4-BE4C-BB49-EFAB79B743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11424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F143A3-3ECD-4948-B415-18897109E6C7}" type="datetime1">
              <a:rPr lang="en-US" smtClean="0"/>
              <a:t>6/15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88919-8FC4-BE4C-BB49-EFAB79B743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72067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70"/>
            <a:ext cx="5829300" cy="1816100"/>
          </a:xfrm>
        </p:spPr>
        <p:txBody>
          <a:bodyPr anchor="t"/>
          <a:lstStyle>
            <a:lvl1pPr algn="l">
              <a:defRPr sz="3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1pPr>
            <a:lvl2pPr marL="342876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2pPr>
            <a:lvl3pPr marL="685752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627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4pPr>
            <a:lvl5pPr marL="1371503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5pPr>
            <a:lvl6pPr marL="1714379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6pPr>
            <a:lvl7pPr marL="2057255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7pPr>
            <a:lvl8pPr marL="2400131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8pPr>
            <a:lvl9pPr marL="2743006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67CD7D-1279-9E45-B2FC-168836509A62}" type="datetime1">
              <a:rPr lang="en-US" smtClean="0"/>
              <a:t>6/15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88919-8FC4-BE4C-BB49-EFAB79B743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38134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9"/>
            <a:ext cx="3028950" cy="6034617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9"/>
            <a:ext cx="3028950" cy="6034617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DCBD0C-A271-5845-92BE-05E73CD27EFB}" type="datetime1">
              <a:rPr lang="en-US" smtClean="0"/>
              <a:t>6/15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88919-8FC4-BE4C-BB49-EFAB79B743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4305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046825"/>
            <a:ext cx="3030141" cy="853017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76" indent="0">
              <a:buNone/>
              <a:defRPr sz="1500" b="1"/>
            </a:lvl2pPr>
            <a:lvl3pPr marL="685752" indent="0">
              <a:buNone/>
              <a:defRPr sz="1350" b="1"/>
            </a:lvl3pPr>
            <a:lvl4pPr marL="1028627" indent="0">
              <a:buNone/>
              <a:defRPr sz="1200" b="1"/>
            </a:lvl4pPr>
            <a:lvl5pPr marL="1371503" indent="0">
              <a:buNone/>
              <a:defRPr sz="1200" b="1"/>
            </a:lvl5pPr>
            <a:lvl6pPr marL="1714379" indent="0">
              <a:buNone/>
              <a:defRPr sz="1200" b="1"/>
            </a:lvl6pPr>
            <a:lvl7pPr marL="2057255" indent="0">
              <a:buNone/>
              <a:defRPr sz="1200" b="1"/>
            </a:lvl7pPr>
            <a:lvl8pPr marL="2400131" indent="0">
              <a:buNone/>
              <a:defRPr sz="1200" b="1"/>
            </a:lvl8pPr>
            <a:lvl9pPr marL="2743006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6" y="2046825"/>
            <a:ext cx="3031331" cy="853017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76" indent="0">
              <a:buNone/>
              <a:defRPr sz="1500" b="1"/>
            </a:lvl2pPr>
            <a:lvl3pPr marL="685752" indent="0">
              <a:buNone/>
              <a:defRPr sz="1350" b="1"/>
            </a:lvl3pPr>
            <a:lvl4pPr marL="1028627" indent="0">
              <a:buNone/>
              <a:defRPr sz="1200" b="1"/>
            </a:lvl4pPr>
            <a:lvl5pPr marL="1371503" indent="0">
              <a:buNone/>
              <a:defRPr sz="1200" b="1"/>
            </a:lvl5pPr>
            <a:lvl6pPr marL="1714379" indent="0">
              <a:buNone/>
              <a:defRPr sz="1200" b="1"/>
            </a:lvl6pPr>
            <a:lvl7pPr marL="2057255" indent="0">
              <a:buNone/>
              <a:defRPr sz="1200" b="1"/>
            </a:lvl7pPr>
            <a:lvl8pPr marL="2400131" indent="0">
              <a:buNone/>
              <a:defRPr sz="1200" b="1"/>
            </a:lvl8pPr>
            <a:lvl9pPr marL="2743006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6" y="2899833"/>
            <a:ext cx="3031331" cy="5268384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9DF09D-9270-CC4B-AA76-04B762AB7855}" type="datetime1">
              <a:rPr lang="en-US" smtClean="0"/>
              <a:t>6/15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88919-8FC4-BE4C-BB49-EFAB79B743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89281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443D19-3E3C-8946-8D3F-1C093822F32A}" type="datetime1">
              <a:rPr lang="en-US" smtClean="0"/>
              <a:t>6/15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88919-8FC4-BE4C-BB49-EFAB79B743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24900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008008-C67D-FD4D-B922-AE7A1313BFD7}" type="datetime1">
              <a:rPr lang="en-US" smtClean="0"/>
              <a:t>6/15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88919-8FC4-BE4C-BB49-EFAB79B743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3413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7" y="364073"/>
            <a:ext cx="2256235" cy="1549401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9" y="364078"/>
            <a:ext cx="3833813" cy="780415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7" y="1913474"/>
            <a:ext cx="2256235" cy="6254751"/>
          </a:xfrm>
        </p:spPr>
        <p:txBody>
          <a:bodyPr/>
          <a:lstStyle>
            <a:lvl1pPr marL="0" indent="0">
              <a:buNone/>
              <a:defRPr sz="1050"/>
            </a:lvl1pPr>
            <a:lvl2pPr marL="342876" indent="0">
              <a:buNone/>
              <a:defRPr sz="900"/>
            </a:lvl2pPr>
            <a:lvl3pPr marL="685752" indent="0">
              <a:buNone/>
              <a:defRPr sz="750"/>
            </a:lvl3pPr>
            <a:lvl4pPr marL="1028627" indent="0">
              <a:buNone/>
              <a:defRPr sz="675"/>
            </a:lvl4pPr>
            <a:lvl5pPr marL="1371503" indent="0">
              <a:buNone/>
              <a:defRPr sz="675"/>
            </a:lvl5pPr>
            <a:lvl6pPr marL="1714379" indent="0">
              <a:buNone/>
              <a:defRPr sz="675"/>
            </a:lvl6pPr>
            <a:lvl7pPr marL="2057255" indent="0">
              <a:buNone/>
              <a:defRPr sz="675"/>
            </a:lvl7pPr>
            <a:lvl8pPr marL="2400131" indent="0">
              <a:buNone/>
              <a:defRPr sz="675"/>
            </a:lvl8pPr>
            <a:lvl9pPr marL="2743006" indent="0">
              <a:buNone/>
              <a:defRPr sz="67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76A988-C676-FF42-891E-FB1AE47133AF}" type="datetime1">
              <a:rPr lang="en-US" smtClean="0"/>
              <a:t>6/15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88919-8FC4-BE4C-BB49-EFAB79B743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51187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2"/>
            <a:ext cx="4114800" cy="755652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2400"/>
            </a:lvl1pPr>
            <a:lvl2pPr marL="342876" indent="0">
              <a:buNone/>
              <a:defRPr sz="2100"/>
            </a:lvl2pPr>
            <a:lvl3pPr marL="685752" indent="0">
              <a:buNone/>
              <a:defRPr sz="1800"/>
            </a:lvl3pPr>
            <a:lvl4pPr marL="1028627" indent="0">
              <a:buNone/>
              <a:defRPr sz="1500"/>
            </a:lvl4pPr>
            <a:lvl5pPr marL="1371503" indent="0">
              <a:buNone/>
              <a:defRPr sz="1500"/>
            </a:lvl5pPr>
            <a:lvl6pPr marL="1714379" indent="0">
              <a:buNone/>
              <a:defRPr sz="1500"/>
            </a:lvl6pPr>
            <a:lvl7pPr marL="2057255" indent="0">
              <a:buNone/>
              <a:defRPr sz="1500"/>
            </a:lvl7pPr>
            <a:lvl8pPr marL="2400131" indent="0">
              <a:buNone/>
              <a:defRPr sz="1500"/>
            </a:lvl8pPr>
            <a:lvl9pPr marL="2743006" indent="0">
              <a:buNone/>
              <a:defRPr sz="15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62"/>
            <a:ext cx="4114800" cy="1073151"/>
          </a:xfrm>
        </p:spPr>
        <p:txBody>
          <a:bodyPr/>
          <a:lstStyle>
            <a:lvl1pPr marL="0" indent="0">
              <a:buNone/>
              <a:defRPr sz="1050"/>
            </a:lvl1pPr>
            <a:lvl2pPr marL="342876" indent="0">
              <a:buNone/>
              <a:defRPr sz="900"/>
            </a:lvl2pPr>
            <a:lvl3pPr marL="685752" indent="0">
              <a:buNone/>
              <a:defRPr sz="750"/>
            </a:lvl3pPr>
            <a:lvl4pPr marL="1028627" indent="0">
              <a:buNone/>
              <a:defRPr sz="675"/>
            </a:lvl4pPr>
            <a:lvl5pPr marL="1371503" indent="0">
              <a:buNone/>
              <a:defRPr sz="675"/>
            </a:lvl5pPr>
            <a:lvl6pPr marL="1714379" indent="0">
              <a:buNone/>
              <a:defRPr sz="675"/>
            </a:lvl6pPr>
            <a:lvl7pPr marL="2057255" indent="0">
              <a:buNone/>
              <a:defRPr sz="675"/>
            </a:lvl7pPr>
            <a:lvl8pPr marL="2400131" indent="0">
              <a:buNone/>
              <a:defRPr sz="675"/>
            </a:lvl8pPr>
            <a:lvl9pPr marL="2743006" indent="0">
              <a:buNone/>
              <a:defRPr sz="67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5FBC4E-AE60-FB42-96D0-73CE1CABC363}" type="datetime1">
              <a:rPr lang="en-US" smtClean="0"/>
              <a:t>6/15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88919-8FC4-BE4C-BB49-EFAB79B743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16123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5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9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4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2E5DFD-486E-7843-BB9E-DC1D8893D936}" type="datetime1">
              <a:rPr lang="en-US" smtClean="0"/>
              <a:t>6/15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4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4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E88919-8FC4-BE4C-BB49-EFAB79B743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80105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lvl1pPr algn="ctr" defTabSz="342876" rtl="0" eaLnBrk="1" latinLnBrk="0" hangingPunct="1"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7156" indent="-257156" algn="l" defTabSz="342876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557174" indent="-214298" algn="l" defTabSz="342876" rtl="0" eaLnBrk="1" latinLnBrk="0" hangingPunct="1">
        <a:spcBef>
          <a:spcPct val="20000"/>
        </a:spcBef>
        <a:buFont typeface="Arial"/>
        <a:buChar char="–"/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57190" indent="-171438" algn="l" defTabSz="342876" rtl="0" eaLnBrk="1" latinLnBrk="0" hangingPunct="1">
        <a:spcBef>
          <a:spcPct val="200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065" indent="-171438" algn="l" defTabSz="342876" rtl="0" eaLnBrk="1" latinLnBrk="0" hangingPunct="1">
        <a:spcBef>
          <a:spcPct val="20000"/>
        </a:spcBef>
        <a:buFont typeface="Arial"/>
        <a:buChar char="–"/>
        <a:defRPr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42941" indent="-171438" algn="l" defTabSz="342876" rtl="0" eaLnBrk="1" latinLnBrk="0" hangingPunct="1">
        <a:spcBef>
          <a:spcPct val="20000"/>
        </a:spcBef>
        <a:buFont typeface="Arial"/>
        <a:buChar char="»"/>
        <a:defRPr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817" indent="-171438" algn="l" defTabSz="342876" rtl="0" eaLnBrk="1" latinLnBrk="0" hangingPunct="1">
        <a:spcBef>
          <a:spcPct val="20000"/>
        </a:spcBef>
        <a:buFont typeface="Arial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28693" indent="-171438" algn="l" defTabSz="342876" rtl="0" eaLnBrk="1" latinLnBrk="0" hangingPunct="1">
        <a:spcBef>
          <a:spcPct val="20000"/>
        </a:spcBef>
        <a:buFont typeface="Arial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571568" indent="-171438" algn="l" defTabSz="342876" rtl="0" eaLnBrk="1" latinLnBrk="0" hangingPunct="1">
        <a:spcBef>
          <a:spcPct val="20000"/>
        </a:spcBef>
        <a:buFont typeface="Arial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914445" indent="-171438" algn="l" defTabSz="342876" rtl="0" eaLnBrk="1" latinLnBrk="0" hangingPunct="1">
        <a:spcBef>
          <a:spcPct val="20000"/>
        </a:spcBef>
        <a:buFont typeface="Arial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42876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876" algn="l" defTabSz="342876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752" algn="l" defTabSz="342876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627" algn="l" defTabSz="342876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503" algn="l" defTabSz="342876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379" algn="l" defTabSz="342876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255" algn="l" defTabSz="342876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131" algn="l" defTabSz="342876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006" algn="l" defTabSz="342876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>
            <a:extLst>
              <a:ext uri="{FF2B5EF4-FFF2-40B4-BE49-F238E27FC236}">
                <a16:creationId xmlns:a16="http://schemas.microsoft.com/office/drawing/2014/main" id="{F1BC2FCB-1D68-5E40-B5D2-FE5FFBFBE9E9}"/>
              </a:ext>
            </a:extLst>
          </p:cNvPr>
          <p:cNvSpPr/>
          <p:nvPr/>
        </p:nvSpPr>
        <p:spPr>
          <a:xfrm>
            <a:off x="0" y="8173120"/>
            <a:ext cx="6724650" cy="8071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>
              <a:lnSpc>
                <a:spcPct val="150000"/>
              </a:lnSpc>
            </a:pPr>
            <a:r>
              <a:rPr lang="en-US" sz="1200" b="1" dirty="0">
                <a:solidFill>
                  <a:prstClr val="black"/>
                </a:solidFill>
              </a:rPr>
              <a:t>Supplemental Figure </a:t>
            </a:r>
            <a:r>
              <a:rPr lang="en-US" altLang="ko-KR" sz="1200" b="1" dirty="0">
                <a:solidFill>
                  <a:prstClr val="black"/>
                </a:solidFill>
              </a:rPr>
              <a:t>4</a:t>
            </a:r>
            <a:r>
              <a:rPr lang="en-US" sz="1200" b="1" dirty="0">
                <a:solidFill>
                  <a:prstClr val="black"/>
                </a:solidFill>
              </a:rPr>
              <a:t>. </a:t>
            </a:r>
            <a:r>
              <a:rPr lang="en-US" sz="1200" dirty="0">
                <a:solidFill>
                  <a:prstClr val="black"/>
                </a:solidFill>
              </a:rPr>
              <a:t>Comparisons of the wall thickness of heart by allele group of ADIPOQ</a:t>
            </a:r>
          </a:p>
          <a:p>
            <a:pPr lvl="0" algn="just">
              <a:lnSpc>
                <a:spcPct val="150000"/>
              </a:lnSpc>
            </a:pPr>
            <a:r>
              <a:rPr lang="en-US" sz="1000" dirty="0">
                <a:solidFill>
                  <a:prstClr val="black"/>
                </a:solidFill>
              </a:rPr>
              <a:t>We </a:t>
            </a:r>
            <a:r>
              <a:rPr lang="en-US" sz="1000" dirty="0"/>
              <a:t>shows the measured wall thickness (mm) from 16 different site of heart between ADIPOQ-W (major allele GG) and ADIPOQ-M (minor allele AG). The red box is the averaged thickness across those sites.</a:t>
            </a:r>
            <a:endParaRPr lang="en-US" sz="1000" dirty="0">
              <a:solidFill>
                <a:prstClr val="black"/>
              </a:solidFill>
            </a:endParaRP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EB7F6D7F-83CA-1441-B113-3068C5EA9279}"/>
              </a:ext>
            </a:extLst>
          </p:cNvPr>
          <p:cNvPicPr>
            <a:picLocks noChangeAspect="1"/>
          </p:cNvPicPr>
          <p:nvPr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8208" y="632883"/>
            <a:ext cx="6741583" cy="6741583"/>
          </a:xfrm>
          <a:prstGeom prst="rect">
            <a:avLst/>
          </a:prstGeom>
        </p:spPr>
      </p:pic>
      <p:sp>
        <p:nvSpPr>
          <p:cNvPr id="11" name="Rectangle 10">
            <a:extLst>
              <a:ext uri="{FF2B5EF4-FFF2-40B4-BE49-F238E27FC236}">
                <a16:creationId xmlns:a16="http://schemas.microsoft.com/office/drawing/2014/main" id="{04861392-3825-D042-9E78-C57649EA50E4}"/>
              </a:ext>
            </a:extLst>
          </p:cNvPr>
          <p:cNvSpPr/>
          <p:nvPr/>
        </p:nvSpPr>
        <p:spPr>
          <a:xfrm>
            <a:off x="4690533" y="5334000"/>
            <a:ext cx="948267" cy="1879600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47077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9704</TotalTime>
  <Words>56</Words>
  <Application>Microsoft Macintosh PowerPoint</Application>
  <PresentationFormat>On-screen Show (4:3)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haracterizing the temporal patterns of diseases and deaths at scale using healthcare records from over 2.1 million patients </dc:title>
  <dc:creator>Hyojung</dc:creator>
  <cp:lastModifiedBy>paik hyojung</cp:lastModifiedBy>
  <cp:revision>453</cp:revision>
  <cp:lastPrinted>2017-11-24T05:57:05Z</cp:lastPrinted>
  <dcterms:created xsi:type="dcterms:W3CDTF">2017-02-28T05:08:16Z</dcterms:created>
  <dcterms:modified xsi:type="dcterms:W3CDTF">2022-06-15T09:12:21Z</dcterms:modified>
</cp:coreProperties>
</file>